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B11029-896A-4BF6-BA93-0A54C3800A12}" type="slidenum">
              <a:rPr b="0" lang="sv-S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C2DA22-17A7-4DD9-BD8D-9C0495A5211C}" type="slidenum">
              <a:rPr b="0" lang="sv-S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35E7F-4574-412A-B68A-D429F7F046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F1C2D-0598-4747-A55E-1368D1A492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DF4EF-3B4F-4889-9C99-C1DD844143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56A5D-B53E-49A0-B033-DC09EBE297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26A70-A106-4F9F-B135-5C3DFC3C1F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CC0A1-E30D-448D-8259-00BCF884E4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4A42F-300D-4AAF-B9E0-088ED987D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6AF5E-4E7F-4B10-9DA8-89BAE2EF8F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D865B-8B9F-449B-AF6E-1F21B11DF5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772C0-80E3-4257-B309-B36E2C0450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21797-FA11-45B7-8E6F-1E7B228939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D1B3F1-0032-44F6-85B7-02ADE75C6C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AF0BA0-BE6E-403A-AE32-157BA6A64056}" type="slidenum">
              <a:rPr b="0" lang="sv-S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50920" y="692280"/>
          <a:ext cx="8642160" cy="4249440"/>
        </p:xfrm>
        <a:graphic>
          <a:graphicData uri="http://schemas.openxmlformats.org/drawingml/2006/table">
            <a:tbl>
              <a:tblPr/>
              <a:tblGrid>
                <a:gridCol w="2303280"/>
                <a:gridCol w="720720"/>
                <a:gridCol w="825480"/>
                <a:gridCol w="654120"/>
                <a:gridCol w="689040"/>
                <a:gridCol w="728640"/>
                <a:gridCol w="701640"/>
                <a:gridCol w="701640"/>
                <a:gridCol w="692280"/>
                <a:gridCol w="625320"/>
              </a:tblGrid>
              <a:tr h="3524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TTR varia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IPTG/+IP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,4-D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-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-N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-H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-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-N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63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T Dnt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±</a:t>
                      </a: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8±1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6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27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0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0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89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0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8±20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4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3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±8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9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4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74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±8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8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5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0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232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5±8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5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69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±1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±2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1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9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1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±10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69L/P227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4±1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±9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8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69L/K189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6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7±1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3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00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69L/K189R/P227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8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7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9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74V/H169L/P227S/K189R/I232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±1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69±13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±1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6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1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74V/H169L/P227S/K189R/I232V/T46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2±9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±1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6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±2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74V/H169L/P227S/K189R/I232V/N49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86±20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6±10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5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±1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4±1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45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”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tdR”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±2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0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±5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±8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±1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±7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±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±3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±20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”</a:t>
                      </a:r>
                      <a:r>
                        <a:rPr b="1" lang="sv-SE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gR”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±29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4±60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8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9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±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±2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±4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3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±3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06T11:29:56Z</dcterms:created>
  <dc:creator>rosa</dc:creator>
  <dc:description/>
  <dc:language>en-US</dc:language>
  <cp:lastModifiedBy>Peter Brzezinski</cp:lastModifiedBy>
  <dcterms:modified xsi:type="dcterms:W3CDTF">2011-08-18T09:56:30Z</dcterms:modified>
  <cp:revision>269</cp:revision>
  <dc:subject/>
  <dc:title>Slide 1</dc:title>
</cp:coreProperties>
</file>